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6" autoAdjust="0"/>
    <p:restoredTop sz="94660"/>
  </p:normalViewPr>
  <p:slideViewPr>
    <p:cSldViewPr snapToGrid="0">
      <p:cViewPr>
        <p:scale>
          <a:sx n="64" d="100"/>
          <a:sy n="64" d="100"/>
        </p:scale>
        <p:origin x="499" y="4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4F3B93-279D-C3E5-D0C9-3B78899D96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5B19D3-1031-C06A-4C8B-F4DBCEB16A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5CC054-B547-C953-3E3F-4D962230F6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4154C5-2BBE-60B3-5541-59B225738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2D36A-5E1E-4D0F-4A19-86B7F76CB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6259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87D36-387A-87F3-0455-89C9369C1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1A1194-081B-831E-B570-1D0C4726C3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A48DD1-8256-C312-CA64-147209DFF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66213C-87CF-8F12-9B11-3D2326F07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B9C22B-6177-520D-12EE-DFB4F19F1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762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A707D4-AB35-7B23-B6F0-E2910380D3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E9F5F2-68C1-F438-F0F2-A276839BA0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F8D4C6-FD46-D946-3F82-EA4EF8288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411181-09F3-E3C0-300B-D1672F5CF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09AC24-86B5-9E65-F007-7010EE8E7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96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1EA56-CBF7-7F7F-22CC-29E47B3423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A7B225-4C5D-8A49-BFD6-A01FFF9C93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1305A-49C0-BFC4-ABAD-9109A29BA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907605-B55E-BFD6-16D3-B878478E8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D865C-FE6D-917A-5AED-CCABBB07A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2953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3972F-A159-7AA2-CD73-07AFDD8B4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0C6824-A8FD-1D93-F536-1CD08DD102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86AD04-4446-0C81-02F3-66FBB1C16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81992D-909A-3109-EF22-A59280A09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4AFD4F-C8DF-413A-B512-24AC75364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990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08A1D4-D0CF-91E5-596F-F67FFD0E57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298CDA-7FCD-7559-AA0C-8A44F0DC73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711C3D-2FD3-1F27-2771-5A53146AEF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33EE0B-6704-880E-3B67-49CD86B94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CD2A2C-526F-FCDB-AE64-9C7CA8AE5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90D94E-D66D-953A-6A18-A1CE291A2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233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28468A-A88A-C073-8C04-CA20A86E7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A969BE-D027-F2F7-D3E9-C9F1B73758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53D255-4175-63EF-8B9A-221D6DA644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82E7C8-67D8-0E25-76B9-15B955F834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7E8EED-A27C-18B0-A56A-D3F4933546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F9D239-D210-5537-7954-6921A6706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D3583A-3048-D79F-6347-B0AB5228E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FAB55A-24BE-D9FF-F3A4-B8F17CE82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501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313D1-84DD-871B-C610-3C4223E53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FA094B-A84F-43F0-D72E-D6B407F6A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4C9DE3-6EB0-594E-DBC2-40F0BB9500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45F4C9-27D4-54CB-2697-698BF9512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238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D508EB-9532-4CF9-B5C4-F86A4FA86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A480A9-F3BC-636A-BE8A-8214D2D69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082AF9-6561-53D5-89F8-F85487587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085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7E81F6-BA7D-FBC8-D892-B5E15A4BF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9D66B1-993B-0086-BEA4-7E883E218E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1796A8-566D-947C-E6FF-0E0E91C346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CDEBA4-5245-337F-871F-D97C8B97E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9D6D70-0796-0CEE-3EEE-C46B15607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C9A47B-7525-977E-6EBD-35EFB88E5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86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35D27-BF0C-0E31-2DA9-0337648C4E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8DA397-F17C-782A-9B81-B8E39EDD7A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3C92DA-9829-50FD-C327-4AA6CB43B7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98D212-2280-667C-CF2C-2AD2B14AD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FD61C6-A2DC-9766-5195-508456570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33797E-2F4A-7690-1908-9B53492AC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41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686695-A2B6-6FE3-BC06-4A03F160E7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7BDD30-9934-4957-0E69-E46A4D7740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0763C-8A28-E92E-8F06-D7122A3C3A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5B667-DADA-46FA-8CD6-5347B91E8402}" type="datetimeFigureOut">
              <a:rPr lang="en-GB" smtClean="0"/>
              <a:t>30/10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48473-0ED7-C11D-B60B-128D9749FA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B547C8-133D-580D-5173-EEB4F7401A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769D0-96B4-406C-9425-69B5B4CF7D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0077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0D9CA-FA00-8FF7-FEAA-3D2800CF104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957569-7456-1AF1-A221-C2B7A83FD4D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75305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494A4-712D-0B26-9589-E89BC87C9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919433D1-FAE4-7855-4879-4EF21C955A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rot="16200000">
            <a:off x="5605420" y="2739462"/>
            <a:ext cx="2681942" cy="4020113"/>
          </a:xfr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E3C432B-DAAE-F253-D6F9-CDDA524104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895197" y="-296558"/>
            <a:ext cx="2752707" cy="40725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49AD370-2E35-9F93-DA61-47C6D9121C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959335" y="2757394"/>
            <a:ext cx="2676899" cy="402011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20514CA-B0DA-B089-3101-F9958D31E57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412" b="-1412"/>
          <a:stretch/>
        </p:blipFill>
        <p:spPr>
          <a:xfrm rot="16200000">
            <a:off x="5600725" y="-297143"/>
            <a:ext cx="2752706" cy="407374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C17C611-5F27-75C6-A213-DDCADF9DB43F}"/>
              </a:ext>
            </a:extLst>
          </p:cNvPr>
          <p:cNvSpPr txBox="1"/>
          <p:nvPr/>
        </p:nvSpPr>
        <p:spPr>
          <a:xfrm>
            <a:off x="235260" y="6234146"/>
            <a:ext cx="1854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ock HCT11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768FEB-A194-80F4-E17B-5EA4D2A37D0F}"/>
              </a:ext>
            </a:extLst>
          </p:cNvPr>
          <p:cNvSpPr txBox="1"/>
          <p:nvPr/>
        </p:nvSpPr>
        <p:spPr>
          <a:xfrm>
            <a:off x="4829031" y="6234146"/>
            <a:ext cx="226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/>
              <a:t>PDE6H</a:t>
            </a:r>
            <a:r>
              <a:rPr lang="en-GB" dirty="0"/>
              <a:t> KO HCT11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1CF670-34B0-D0C6-9BAD-E36A763A7ADF}"/>
              </a:ext>
            </a:extLst>
          </p:cNvPr>
          <p:cNvSpPr txBox="1"/>
          <p:nvPr/>
        </p:nvSpPr>
        <p:spPr>
          <a:xfrm>
            <a:off x="9013951" y="1553029"/>
            <a:ext cx="1697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</a:t>
            </a:r>
            <a:r>
              <a:rPr lang="el-GR" dirty="0"/>
              <a:t>μ</a:t>
            </a:r>
            <a:r>
              <a:rPr lang="en-GB" dirty="0"/>
              <a:t>M rapamyc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8DE912-A3C5-F20E-88CA-D4055A7CAB43}"/>
              </a:ext>
            </a:extLst>
          </p:cNvPr>
          <p:cNvSpPr txBox="1"/>
          <p:nvPr/>
        </p:nvSpPr>
        <p:spPr>
          <a:xfrm>
            <a:off x="9013950" y="4380186"/>
            <a:ext cx="204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0 </a:t>
            </a:r>
            <a:r>
              <a:rPr lang="el-GR" dirty="0"/>
              <a:t>μ</a:t>
            </a:r>
            <a:r>
              <a:rPr lang="en-GB" dirty="0"/>
              <a:t>M rapamycin</a:t>
            </a:r>
          </a:p>
        </p:txBody>
      </p:sp>
    </p:spTree>
    <p:extLst>
      <p:ext uri="{BB962C8B-B14F-4D97-AF65-F5344CB8AC3E}">
        <p14:creationId xmlns:p14="http://schemas.microsoft.com/office/powerpoint/2010/main" val="2103711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B091604-C09A-FAEB-23BA-8F4E32A12F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5533817" y="572855"/>
            <a:ext cx="1831678" cy="265619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A47ECC5-D7FD-77C1-A982-4DD8B8A838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573780" y="4442107"/>
            <a:ext cx="1808879" cy="271332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9948C25-B9F9-D566-CE87-CB6A39EC19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1450325" y="524134"/>
            <a:ext cx="1822980" cy="273083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EB542FD-751B-B1C3-FA76-A8E4148574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1477041" y="2469549"/>
            <a:ext cx="1788375" cy="273083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4A5904A-BF44-4738-455C-BF8EA4D353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200000">
            <a:off x="1446085" y="4409784"/>
            <a:ext cx="1831457" cy="274966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E878C68-47D2-D271-5806-9EB821B171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200000">
            <a:off x="5553467" y="2508871"/>
            <a:ext cx="1808878" cy="267269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89320B7-BAAA-4871-3F48-BC36712990DC}"/>
              </a:ext>
            </a:extLst>
          </p:cNvPr>
          <p:cNvSpPr txBox="1"/>
          <p:nvPr/>
        </p:nvSpPr>
        <p:spPr>
          <a:xfrm>
            <a:off x="1443830" y="468996"/>
            <a:ext cx="1854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ock HCT11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388233C-47BE-DEAE-6731-934EC72A617A}"/>
              </a:ext>
            </a:extLst>
          </p:cNvPr>
          <p:cNvSpPr txBox="1"/>
          <p:nvPr/>
        </p:nvSpPr>
        <p:spPr>
          <a:xfrm>
            <a:off x="5509298" y="471110"/>
            <a:ext cx="226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/>
              <a:t>PDE6H</a:t>
            </a:r>
            <a:r>
              <a:rPr lang="en-GB" dirty="0"/>
              <a:t> KO HCT11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D4C662-6DFC-33ED-70C5-4DC87EDFAA84}"/>
              </a:ext>
            </a:extLst>
          </p:cNvPr>
          <p:cNvSpPr txBox="1"/>
          <p:nvPr/>
        </p:nvSpPr>
        <p:spPr>
          <a:xfrm>
            <a:off x="8048751" y="1704887"/>
            <a:ext cx="1697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</a:t>
            </a:r>
            <a:r>
              <a:rPr lang="el-GR" dirty="0"/>
              <a:t>μ</a:t>
            </a:r>
            <a:r>
              <a:rPr lang="en-GB" dirty="0"/>
              <a:t>M sildenafi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16B978-39B1-E286-3138-C796E98CF636}"/>
              </a:ext>
            </a:extLst>
          </p:cNvPr>
          <p:cNvSpPr txBox="1"/>
          <p:nvPr/>
        </p:nvSpPr>
        <p:spPr>
          <a:xfrm>
            <a:off x="8048751" y="3687545"/>
            <a:ext cx="1697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 </a:t>
            </a:r>
            <a:r>
              <a:rPr lang="el-GR" dirty="0"/>
              <a:t>μ</a:t>
            </a:r>
            <a:r>
              <a:rPr lang="en-GB" dirty="0"/>
              <a:t>M sildenafi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E8EAF6F-4372-8CFA-9DBD-3C4C79F9B5DA}"/>
              </a:ext>
            </a:extLst>
          </p:cNvPr>
          <p:cNvSpPr txBox="1"/>
          <p:nvPr/>
        </p:nvSpPr>
        <p:spPr>
          <a:xfrm>
            <a:off x="7992476" y="5599951"/>
            <a:ext cx="1697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0 </a:t>
            </a:r>
            <a:r>
              <a:rPr lang="el-GR" dirty="0"/>
              <a:t>μ</a:t>
            </a:r>
            <a:r>
              <a:rPr lang="en-GB" dirty="0"/>
              <a:t>M sildenafil</a:t>
            </a:r>
          </a:p>
        </p:txBody>
      </p:sp>
    </p:spTree>
    <p:extLst>
      <p:ext uri="{BB962C8B-B14F-4D97-AF65-F5344CB8AC3E}">
        <p14:creationId xmlns:p14="http://schemas.microsoft.com/office/powerpoint/2010/main" val="39626837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6706E1-0C29-3021-05F5-B9CA939B0234}"/>
              </a:ext>
            </a:extLst>
          </p:cNvPr>
          <p:cNvSpPr txBox="1"/>
          <p:nvPr/>
        </p:nvSpPr>
        <p:spPr>
          <a:xfrm>
            <a:off x="11213049" y="1517886"/>
            <a:ext cx="743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iNT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9532DF-79B4-0886-53B6-EED804A26E5D}"/>
              </a:ext>
            </a:extLst>
          </p:cNvPr>
          <p:cNvSpPr txBox="1"/>
          <p:nvPr/>
        </p:nvSpPr>
        <p:spPr>
          <a:xfrm>
            <a:off x="11204701" y="2434880"/>
            <a:ext cx="104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iPDE6H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613DA8A-4DA1-3A00-474E-41294D00D4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7376" y="1133769"/>
            <a:ext cx="3039730" cy="202249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D294F5E-7E5C-477A-6C48-55B2C4E56490}"/>
              </a:ext>
            </a:extLst>
          </p:cNvPr>
          <p:cNvSpPr txBox="1"/>
          <p:nvPr/>
        </p:nvSpPr>
        <p:spPr>
          <a:xfrm>
            <a:off x="11250626" y="4277330"/>
            <a:ext cx="743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iNT</a:t>
            </a:r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B97AC7-58A3-2A9C-FAEB-4A7C57F700D2}"/>
              </a:ext>
            </a:extLst>
          </p:cNvPr>
          <p:cNvSpPr txBox="1"/>
          <p:nvPr/>
        </p:nvSpPr>
        <p:spPr>
          <a:xfrm>
            <a:off x="11250626" y="5203574"/>
            <a:ext cx="104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iPDE6H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EAC88E1-F404-52B0-87F4-D9D255589B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7376" y="3750136"/>
            <a:ext cx="3039732" cy="204983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9D53521-D5A9-B86B-F897-973BBAA6FB9D}"/>
              </a:ext>
            </a:extLst>
          </p:cNvPr>
          <p:cNvSpPr txBox="1"/>
          <p:nvPr/>
        </p:nvSpPr>
        <p:spPr>
          <a:xfrm>
            <a:off x="4817376" y="569379"/>
            <a:ext cx="1104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NCI-H23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DBD0D80-18C3-64BA-EB77-F8DA9894A8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4971" y="1170759"/>
            <a:ext cx="3039730" cy="206048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596906B-E04C-F814-068C-C5E72364C0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64971" y="3797376"/>
            <a:ext cx="3039730" cy="20254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CDE78D5E-D8DB-7604-9A04-18B8CE309119}"/>
              </a:ext>
            </a:extLst>
          </p:cNvPr>
          <p:cNvSpPr txBox="1"/>
          <p:nvPr/>
        </p:nvSpPr>
        <p:spPr>
          <a:xfrm>
            <a:off x="8164971" y="569379"/>
            <a:ext cx="1554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DA-MB-436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9FCD6BED-6432-CA82-9AD3-BC6F532D01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8491" y="1128666"/>
            <a:ext cx="3039730" cy="209747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AE002AD-990D-5C43-CD21-B8DDF3DD142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8491" y="3720730"/>
            <a:ext cx="3039730" cy="207844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50D83029-5092-3DA1-4C3A-9C69C247EBBD}"/>
              </a:ext>
            </a:extLst>
          </p:cNvPr>
          <p:cNvSpPr txBox="1"/>
          <p:nvPr/>
        </p:nvSpPr>
        <p:spPr>
          <a:xfrm>
            <a:off x="276202" y="568525"/>
            <a:ext cx="1554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CT11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F3BF0D-2E8D-6DE4-DB01-0AEF190EC1C8}"/>
              </a:ext>
            </a:extLst>
          </p:cNvPr>
          <p:cNvSpPr txBox="1"/>
          <p:nvPr/>
        </p:nvSpPr>
        <p:spPr>
          <a:xfrm>
            <a:off x="3226569" y="1517886"/>
            <a:ext cx="743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iNT</a:t>
            </a:r>
            <a:endParaRPr lang="en-GB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4740B4A-93E3-35C2-DC6C-AD223A730F92}"/>
              </a:ext>
            </a:extLst>
          </p:cNvPr>
          <p:cNvSpPr txBox="1"/>
          <p:nvPr/>
        </p:nvSpPr>
        <p:spPr>
          <a:xfrm>
            <a:off x="3218221" y="2434880"/>
            <a:ext cx="743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iNT</a:t>
            </a:r>
            <a:endParaRPr lang="en-GB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5045B88-B033-9DE8-8A41-09C22D423840}"/>
              </a:ext>
            </a:extLst>
          </p:cNvPr>
          <p:cNvSpPr txBox="1"/>
          <p:nvPr/>
        </p:nvSpPr>
        <p:spPr>
          <a:xfrm>
            <a:off x="3136416" y="4066675"/>
            <a:ext cx="104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iPDE6H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7AFF5BA-628C-C2DE-D7F7-C36CFE9BC7F8}"/>
              </a:ext>
            </a:extLst>
          </p:cNvPr>
          <p:cNvSpPr txBox="1"/>
          <p:nvPr/>
        </p:nvSpPr>
        <p:spPr>
          <a:xfrm>
            <a:off x="3140073" y="5046299"/>
            <a:ext cx="1044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iPDE6H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82EBFDD-CE2C-2DC0-BD39-0C7B5EADB3DB}"/>
              </a:ext>
            </a:extLst>
          </p:cNvPr>
          <p:cNvCxnSpPr/>
          <p:nvPr/>
        </p:nvCxnSpPr>
        <p:spPr>
          <a:xfrm>
            <a:off x="4331368" y="0"/>
            <a:ext cx="0" cy="6858000"/>
          </a:xfrm>
          <a:prstGeom prst="line">
            <a:avLst/>
          </a:prstGeom>
          <a:ln w="381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99225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9B8E221-259E-81E3-E9E3-7EE91A9765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2158234" y="616912"/>
            <a:ext cx="2686549" cy="402590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35CA9FA-DE85-448E-EA8B-E3E2DD4FC4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2178821" y="3498471"/>
            <a:ext cx="2645377" cy="40259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EFF8CA9-A6B4-C8F9-C8EE-F75E8FD12D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6451031" y="663423"/>
            <a:ext cx="2679455" cy="392272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180C029-4F6A-7EAC-C21A-49DF2CA723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6460113" y="3588513"/>
            <a:ext cx="2624783" cy="384417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2C1DE34-5DCB-F848-6117-6A4133991C76}"/>
              </a:ext>
            </a:extLst>
          </p:cNvPr>
          <p:cNvSpPr txBox="1"/>
          <p:nvPr/>
        </p:nvSpPr>
        <p:spPr>
          <a:xfrm>
            <a:off x="2811344" y="539928"/>
            <a:ext cx="1854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Mock HCT11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B874F7C-AB56-79CE-7C72-0111EDB13192}"/>
              </a:ext>
            </a:extLst>
          </p:cNvPr>
          <p:cNvSpPr txBox="1"/>
          <p:nvPr/>
        </p:nvSpPr>
        <p:spPr>
          <a:xfrm>
            <a:off x="6937525" y="640066"/>
            <a:ext cx="2268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/>
              <a:t>PDE6H</a:t>
            </a:r>
            <a:r>
              <a:rPr lang="en-GB" dirty="0"/>
              <a:t> KO HCT11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16EA02-A59A-7F32-6C36-22ADA7CCBA02}"/>
              </a:ext>
            </a:extLst>
          </p:cNvPr>
          <p:cNvSpPr txBox="1"/>
          <p:nvPr/>
        </p:nvSpPr>
        <p:spPr>
          <a:xfrm>
            <a:off x="10067055" y="2440117"/>
            <a:ext cx="1854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arginin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A7FF17C-0E90-D0B1-BE08-2756A471B6B3}"/>
              </a:ext>
            </a:extLst>
          </p:cNvPr>
          <p:cNvSpPr txBox="1"/>
          <p:nvPr/>
        </p:nvSpPr>
        <p:spPr>
          <a:xfrm>
            <a:off x="10067055" y="5325932"/>
            <a:ext cx="1854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arginine</a:t>
            </a:r>
          </a:p>
        </p:txBody>
      </p:sp>
    </p:spTree>
    <p:extLst>
      <p:ext uri="{BB962C8B-B14F-4D97-AF65-F5344CB8AC3E}">
        <p14:creationId xmlns:p14="http://schemas.microsoft.com/office/powerpoint/2010/main" val="2369301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50</Words>
  <Application>Microsoft Office PowerPoint</Application>
  <PresentationFormat>Widescreen</PresentationFormat>
  <Paragraphs>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en Yalaz</dc:creator>
  <cp:lastModifiedBy>Ceren Yalaz</cp:lastModifiedBy>
  <cp:revision>23</cp:revision>
  <dcterms:created xsi:type="dcterms:W3CDTF">2023-10-30T20:12:51Z</dcterms:created>
  <dcterms:modified xsi:type="dcterms:W3CDTF">2023-10-31T00:44:42Z</dcterms:modified>
</cp:coreProperties>
</file>